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60" r:id="rId3"/>
    <p:sldId id="259" r:id="rId4"/>
    <p:sldId id="261" r:id="rId5"/>
    <p:sldId id="262" r:id="rId6"/>
    <p:sldId id="263" r:id="rId7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08" d="100"/>
          <a:sy n="108" d="100"/>
        </p:scale>
        <p:origin x="-1704" y="-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9A9D96-77DF-4CCE-A80A-CF6122BDE60D}" type="datetimeFigureOut">
              <a:rPr lang="zh-CN" altLang="en-US" smtClean="0"/>
              <a:t>2024/4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FD3D13-6531-486A-AEF2-7968A5F213C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961429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9A9D96-77DF-4CCE-A80A-CF6122BDE60D}" type="datetimeFigureOut">
              <a:rPr lang="zh-CN" altLang="en-US" smtClean="0"/>
              <a:t>2024/4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FD3D13-6531-486A-AEF2-7968A5F213C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558091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9A9D96-77DF-4CCE-A80A-CF6122BDE60D}" type="datetimeFigureOut">
              <a:rPr lang="zh-CN" altLang="en-US" smtClean="0"/>
              <a:t>2024/4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FD3D13-6531-486A-AEF2-7968A5F213C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554466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9A9D96-77DF-4CCE-A80A-CF6122BDE60D}" type="datetimeFigureOut">
              <a:rPr lang="zh-CN" altLang="en-US" smtClean="0"/>
              <a:t>2024/4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FD3D13-6531-486A-AEF2-7968A5F213C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518067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9A9D96-77DF-4CCE-A80A-CF6122BDE60D}" type="datetimeFigureOut">
              <a:rPr lang="zh-CN" altLang="en-US" smtClean="0"/>
              <a:t>2024/4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FD3D13-6531-486A-AEF2-7968A5F213C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265308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9A9D96-77DF-4CCE-A80A-CF6122BDE60D}" type="datetimeFigureOut">
              <a:rPr lang="zh-CN" altLang="en-US" smtClean="0"/>
              <a:t>2024/4/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FD3D13-6531-486A-AEF2-7968A5F213C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646980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9A9D96-77DF-4CCE-A80A-CF6122BDE60D}" type="datetimeFigureOut">
              <a:rPr lang="zh-CN" altLang="en-US" smtClean="0"/>
              <a:t>2024/4/7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FD3D13-6531-486A-AEF2-7968A5F213C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243594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9A9D96-77DF-4CCE-A80A-CF6122BDE60D}" type="datetimeFigureOut">
              <a:rPr lang="zh-CN" altLang="en-US" smtClean="0"/>
              <a:t>2024/4/7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FD3D13-6531-486A-AEF2-7968A5F213C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856826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9A9D96-77DF-4CCE-A80A-CF6122BDE60D}" type="datetimeFigureOut">
              <a:rPr lang="zh-CN" altLang="en-US" smtClean="0"/>
              <a:t>2024/4/7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FD3D13-6531-486A-AEF2-7968A5F213C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19996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9A9D96-77DF-4CCE-A80A-CF6122BDE60D}" type="datetimeFigureOut">
              <a:rPr lang="zh-CN" altLang="en-US" smtClean="0"/>
              <a:t>2024/4/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FD3D13-6531-486A-AEF2-7968A5F213C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838955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9A9D96-77DF-4CCE-A80A-CF6122BDE60D}" type="datetimeFigureOut">
              <a:rPr lang="zh-CN" altLang="en-US" smtClean="0"/>
              <a:t>2024/4/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FD3D13-6531-486A-AEF2-7968A5F213C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147919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9A9D96-77DF-4CCE-A80A-CF6122BDE60D}" type="datetimeFigureOut">
              <a:rPr lang="zh-CN" altLang="en-US" smtClean="0"/>
              <a:t>2024/4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FD3D13-6531-486A-AEF2-7968A5F213C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558632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png"/><Relationship Id="rId4" Type="http://schemas.openxmlformats.org/officeDocument/2006/relationships/image" Target="../media/image3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0.png"/><Relationship Id="rId4" Type="http://schemas.openxmlformats.org/officeDocument/2006/relationships/image" Target="../media/image9.tif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tif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tif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16.png"/><Relationship Id="rId4" Type="http://schemas.openxmlformats.org/officeDocument/2006/relationships/image" Target="../media/image15.tif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/>
          <p:cNvSpPr/>
          <p:nvPr/>
        </p:nvSpPr>
        <p:spPr>
          <a:xfrm>
            <a:off x="179512" y="12069"/>
            <a:ext cx="4572000" cy="646331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estern blotting Gels: </a:t>
            </a:r>
            <a:endParaRPr lang="en-US" altLang="zh-CN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1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074" name="Picture 2" descr="C:\Users\hp\AppData\Local\Temp\360zip$Temp\360$4\AMPKα1一.tif"/>
          <p:cNvPicPr preferRelativeResize="0">
            <a:picLocks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30736" y="836712"/>
            <a:ext cx="2365200" cy="21816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矩形 5"/>
          <p:cNvSpPr/>
          <p:nvPr/>
        </p:nvSpPr>
        <p:spPr>
          <a:xfrm>
            <a:off x="698031" y="1571032"/>
            <a:ext cx="936104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AMPK</a:t>
            </a:r>
            <a:endParaRPr lang="en-US" altLang="zh-CN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62/64 </a:t>
            </a:r>
            <a:r>
              <a:rPr lang="en-US" altLang="zh-CN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zh-CN" altLang="en-US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075" name="Picture 3"/>
          <p:cNvPicPr preferRelativeResize="0">
            <a:picLocks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60032" y="764704"/>
            <a:ext cx="2365200" cy="2181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8" name="矩形 7"/>
          <p:cNvSpPr/>
          <p:nvPr/>
        </p:nvSpPr>
        <p:spPr>
          <a:xfrm>
            <a:off x="7195680" y="1535863"/>
            <a:ext cx="936104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AMPK</a:t>
            </a:r>
            <a:endParaRPr lang="en-US" altLang="zh-CN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62/64 </a:t>
            </a:r>
            <a:r>
              <a:rPr lang="en-US" altLang="zh-CN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zh-CN" altLang="en-US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076" name="Picture 4" descr="C:\Users\hp\AppData\Local\Temp\360zip$Temp\360$5\P-AMPKα1一.tif"/>
          <p:cNvPicPr preferRelativeResize="0">
            <a:picLocks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91680" y="3573016"/>
            <a:ext cx="2365200" cy="21816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0" name="矩形 9"/>
          <p:cNvSpPr/>
          <p:nvPr/>
        </p:nvSpPr>
        <p:spPr>
          <a:xfrm>
            <a:off x="702824" y="4238672"/>
            <a:ext cx="936104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p- AMPK</a:t>
            </a:r>
            <a:endParaRPr lang="en-US" altLang="zh-CN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62/64 </a:t>
            </a:r>
            <a:r>
              <a:rPr lang="en-US" altLang="zh-CN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zh-CN" altLang="en-US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077" name="Picture 5"/>
          <p:cNvPicPr preferRelativeResize="0">
            <a:picLocks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18400" y="3585701"/>
            <a:ext cx="2365200" cy="2181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2" name="矩形 11"/>
          <p:cNvSpPr/>
          <p:nvPr/>
        </p:nvSpPr>
        <p:spPr>
          <a:xfrm>
            <a:off x="7284167" y="4367026"/>
            <a:ext cx="936104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p- AMPK</a:t>
            </a:r>
            <a:endParaRPr lang="en-US" altLang="zh-CN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62/64 </a:t>
            </a:r>
            <a:r>
              <a:rPr lang="en-US" altLang="zh-CN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zh-CN" altLang="en-US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矩形 12"/>
          <p:cNvSpPr/>
          <p:nvPr/>
        </p:nvSpPr>
        <p:spPr>
          <a:xfrm>
            <a:off x="267989" y="5858601"/>
            <a:ext cx="8856984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</a:t>
            </a:r>
            <a:r>
              <a:rPr lang="zh-CN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：</a:t>
            </a:r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apsaicin increased the protein expressions of </a:t>
            </a:r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p- AMPK </a:t>
            </a:r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 the PVN of </a:t>
            </a:r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alt-sensitive hypertensive rats.</a:t>
            </a:r>
            <a:endParaRPr lang="zh-CN" altLang="zh-CN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4183052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 descr="C:\Users\hp\AppData\Local\Temp\360zip$Temp\360$6\ACTIN一.tif"/>
          <p:cNvPicPr preferRelativeResize="0">
            <a:picLocks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99559" y="1141220"/>
            <a:ext cx="2365200" cy="21816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矩形 4"/>
          <p:cNvSpPr/>
          <p:nvPr/>
        </p:nvSpPr>
        <p:spPr>
          <a:xfrm>
            <a:off x="179512" y="12069"/>
            <a:ext cx="4572000" cy="646331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estern blotting Gels: </a:t>
            </a:r>
            <a:endParaRPr lang="en-US" altLang="zh-CN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1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矩形 5"/>
          <p:cNvSpPr/>
          <p:nvPr/>
        </p:nvSpPr>
        <p:spPr>
          <a:xfrm>
            <a:off x="684575" y="1924244"/>
            <a:ext cx="863089" cy="61555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β-actin</a:t>
            </a:r>
          </a:p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43KDa)</a:t>
            </a:r>
            <a:endParaRPr lang="zh-CN" altLang="en-US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zh-CN" alt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099" name="Picture 3"/>
          <p:cNvPicPr preferRelativeResize="0">
            <a:picLocks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51512" y="1090425"/>
            <a:ext cx="2365200" cy="2181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8" name="矩形 7"/>
          <p:cNvSpPr/>
          <p:nvPr/>
        </p:nvSpPr>
        <p:spPr>
          <a:xfrm>
            <a:off x="7236296" y="1873448"/>
            <a:ext cx="863089" cy="61555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β-actin</a:t>
            </a:r>
          </a:p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43KDa)</a:t>
            </a:r>
            <a:endParaRPr lang="zh-CN" altLang="en-US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zh-CN" alt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矩形 8"/>
          <p:cNvSpPr/>
          <p:nvPr/>
        </p:nvSpPr>
        <p:spPr>
          <a:xfrm>
            <a:off x="1037252" y="4410490"/>
            <a:ext cx="6234213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1</a:t>
            </a:r>
            <a:r>
              <a:rPr lang="zh-CN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：</a:t>
            </a:r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ternal reference of each group of proteins</a:t>
            </a:r>
            <a:endParaRPr lang="zh-CN" altLang="zh-CN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0653414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/>
          <p:cNvSpPr/>
          <p:nvPr/>
        </p:nvSpPr>
        <p:spPr>
          <a:xfrm>
            <a:off x="179512" y="12069"/>
            <a:ext cx="4572000" cy="646331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estern blotting Gels: </a:t>
            </a:r>
            <a:endParaRPr lang="en-US" altLang="zh-CN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2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122" name="Picture 2" descr="C:\Users\hp\AppData\Local\Temp\360zip$Temp\360$7\PI3K二.tif"/>
          <p:cNvPicPr preferRelativeResize="0">
            <a:picLocks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55957" y="792873"/>
            <a:ext cx="2365200" cy="21816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矩形 5"/>
          <p:cNvSpPr/>
          <p:nvPr/>
        </p:nvSpPr>
        <p:spPr>
          <a:xfrm>
            <a:off x="935877" y="1512953"/>
            <a:ext cx="863089" cy="61555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PI3K</a:t>
            </a:r>
            <a:endParaRPr lang="en-US" altLang="zh-CN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85KDa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zh-CN" altLang="en-US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zh-CN" alt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123" name="Picture 3"/>
          <p:cNvPicPr preferRelativeResize="0">
            <a:picLocks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68325" y="792873"/>
            <a:ext cx="2365200" cy="2185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8" name="矩形 7"/>
          <p:cNvSpPr/>
          <p:nvPr/>
        </p:nvSpPr>
        <p:spPr>
          <a:xfrm>
            <a:off x="7372251" y="1337578"/>
            <a:ext cx="863089" cy="61555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PI3K</a:t>
            </a:r>
            <a:endParaRPr lang="en-US" altLang="zh-CN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85KDa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zh-CN" altLang="en-US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zh-CN" alt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124" name="Picture 4" descr="C:\Users\hp\AppData\Local\Temp\360zip$Temp\360$8\P-PI3K二.tif"/>
          <p:cNvPicPr preferRelativeResize="0">
            <a:picLocks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32692" y="3400192"/>
            <a:ext cx="2365200" cy="21816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0" name="矩形 9"/>
          <p:cNvSpPr/>
          <p:nvPr/>
        </p:nvSpPr>
        <p:spPr>
          <a:xfrm>
            <a:off x="769603" y="4068008"/>
            <a:ext cx="863089" cy="61555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p- PI3K</a:t>
            </a:r>
            <a:endParaRPr lang="en-US" altLang="zh-CN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85KDa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zh-CN" altLang="en-US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zh-CN" alt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125" name="Picture 5"/>
          <p:cNvPicPr preferRelativeResize="0">
            <a:picLocks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68325" y="3284984"/>
            <a:ext cx="2365200" cy="2181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2" name="矩形 11"/>
          <p:cNvSpPr/>
          <p:nvPr/>
        </p:nvSpPr>
        <p:spPr>
          <a:xfrm>
            <a:off x="7349927" y="4099809"/>
            <a:ext cx="863089" cy="61555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p- PI3K</a:t>
            </a:r>
            <a:endParaRPr lang="en-US" altLang="zh-CN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85KDa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zh-CN" altLang="en-US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zh-CN" alt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矩形 12"/>
          <p:cNvSpPr/>
          <p:nvPr/>
        </p:nvSpPr>
        <p:spPr>
          <a:xfrm>
            <a:off x="267989" y="5858601"/>
            <a:ext cx="8856984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2</a:t>
            </a:r>
            <a:r>
              <a:rPr lang="zh-CN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：</a:t>
            </a:r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apsaicin </a:t>
            </a:r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ecreased </a:t>
            </a:r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protein expressions of </a:t>
            </a:r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p- PI3K </a:t>
            </a:r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 the PVN of </a:t>
            </a:r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alt-sensitive hypertensive rats.</a:t>
            </a:r>
            <a:endParaRPr lang="zh-CN" altLang="zh-CN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4542923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/>
          <p:cNvSpPr/>
          <p:nvPr/>
        </p:nvSpPr>
        <p:spPr>
          <a:xfrm>
            <a:off x="179512" y="12069"/>
            <a:ext cx="4572000" cy="646331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estern blotting Gels: </a:t>
            </a:r>
            <a:endParaRPr lang="en-US" altLang="zh-CN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2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矩形 4"/>
          <p:cNvSpPr/>
          <p:nvPr/>
        </p:nvSpPr>
        <p:spPr>
          <a:xfrm>
            <a:off x="791575" y="2226087"/>
            <a:ext cx="863089" cy="61555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β-actin</a:t>
            </a:r>
          </a:p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43KDa)</a:t>
            </a:r>
            <a:endParaRPr lang="zh-CN" altLang="en-US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zh-CN" alt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矩形 5"/>
          <p:cNvSpPr/>
          <p:nvPr/>
        </p:nvSpPr>
        <p:spPr>
          <a:xfrm>
            <a:off x="7137418" y="2411823"/>
            <a:ext cx="863089" cy="61555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β-actin</a:t>
            </a:r>
          </a:p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43KDa)</a:t>
            </a:r>
            <a:endParaRPr lang="zh-CN" altLang="en-US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zh-CN" alt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146" name="Picture 2" descr="C:\Users\hp\AppData\Local\Temp\360zip$Temp\360$10\ACTIN二.tif"/>
          <p:cNvPicPr preferRelativeResize="0">
            <a:picLocks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34432" y="1628800"/>
            <a:ext cx="2365200" cy="21816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147" name="Picture 3"/>
          <p:cNvPicPr preferRelativeResize="0">
            <a:picLocks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51512" y="1628800"/>
            <a:ext cx="2365200" cy="2181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9" name="矩形 8"/>
          <p:cNvSpPr/>
          <p:nvPr/>
        </p:nvSpPr>
        <p:spPr>
          <a:xfrm>
            <a:off x="1362123" y="4437112"/>
            <a:ext cx="6018189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2</a:t>
            </a:r>
            <a:r>
              <a:rPr lang="zh-CN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：</a:t>
            </a:r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ternal reference of each group of proteins</a:t>
            </a:r>
            <a:endParaRPr lang="zh-CN" altLang="zh-CN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6170650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/>
          <p:cNvSpPr/>
          <p:nvPr/>
        </p:nvSpPr>
        <p:spPr>
          <a:xfrm>
            <a:off x="179512" y="12069"/>
            <a:ext cx="4572000" cy="646331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estern blotting Gels: </a:t>
            </a:r>
            <a:endParaRPr lang="en-US" altLang="zh-CN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3 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26" name="Picture 2" descr="C:\Users\hp\AppData\Local\Temp\360zip$Temp\360$0\AKT三.tif"/>
          <p:cNvPicPr preferRelativeResize="0">
            <a:picLocks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07704" y="548680"/>
            <a:ext cx="2181600" cy="23652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矩形 5"/>
          <p:cNvSpPr/>
          <p:nvPr/>
        </p:nvSpPr>
        <p:spPr>
          <a:xfrm>
            <a:off x="971600" y="4221087"/>
            <a:ext cx="936104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p- AKT</a:t>
            </a:r>
            <a:endParaRPr lang="en-US" altLang="zh-CN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(60 </a:t>
            </a:r>
            <a:r>
              <a:rPr lang="en-US" altLang="zh-CN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zh-CN" altLang="en-US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28" name="Picture 4"/>
          <p:cNvPicPr preferRelativeResize="0">
            <a:picLocks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95528" y="653920"/>
            <a:ext cx="2304256" cy="244275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9" name="Picture 5" descr="C:\Users\hp\AppData\Local\Temp\360zip$Temp\360$1\P-AKT三.tif"/>
          <p:cNvPicPr preferRelativeResize="0">
            <a:picLocks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07704" y="3493271"/>
            <a:ext cx="2181600" cy="23652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0" name="矩形 9"/>
          <p:cNvSpPr/>
          <p:nvPr/>
        </p:nvSpPr>
        <p:spPr>
          <a:xfrm>
            <a:off x="1111215" y="1256987"/>
            <a:ext cx="936104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AKT</a:t>
            </a:r>
            <a:endParaRPr lang="en-US" altLang="zh-CN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60 </a:t>
            </a:r>
            <a:r>
              <a:rPr lang="en-US" altLang="zh-CN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zh-CN" altLang="en-US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30" name="Picture 6"/>
          <p:cNvPicPr preferRelativeResize="0">
            <a:picLocks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22131" y="3477057"/>
            <a:ext cx="2290120" cy="2365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2" name="矩形 11"/>
          <p:cNvSpPr/>
          <p:nvPr/>
        </p:nvSpPr>
        <p:spPr>
          <a:xfrm>
            <a:off x="7217477" y="4149171"/>
            <a:ext cx="936104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p- AKT</a:t>
            </a:r>
            <a:endParaRPr lang="en-US" altLang="zh-CN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(60 </a:t>
            </a:r>
            <a:r>
              <a:rPr lang="en-US" altLang="zh-CN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zh-CN" altLang="en-US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矩形 12"/>
          <p:cNvSpPr/>
          <p:nvPr/>
        </p:nvSpPr>
        <p:spPr>
          <a:xfrm>
            <a:off x="7226043" y="1228965"/>
            <a:ext cx="936104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AKT</a:t>
            </a:r>
            <a:endParaRPr lang="en-US" altLang="zh-CN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60 </a:t>
            </a:r>
            <a:r>
              <a:rPr lang="en-US" altLang="zh-CN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zh-CN" altLang="en-US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矩形 10"/>
          <p:cNvSpPr/>
          <p:nvPr/>
        </p:nvSpPr>
        <p:spPr>
          <a:xfrm>
            <a:off x="267989" y="6021288"/>
            <a:ext cx="8856984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3</a:t>
            </a:r>
            <a:r>
              <a:rPr lang="zh-CN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：</a:t>
            </a:r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apsaicin </a:t>
            </a:r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ecreased </a:t>
            </a:r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protein expressions of </a:t>
            </a:r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p- AKT </a:t>
            </a:r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 the PVN of </a:t>
            </a:r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alt-sensitive hypertensive rats.</a:t>
            </a:r>
            <a:endParaRPr lang="zh-CN" altLang="zh-CN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758619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 descr="C:\Users\hp\AppData\Local\Temp\360zip$Temp\360$2\ACTIN一.tif"/>
          <p:cNvPicPr preferRelativeResize="0">
            <a:picLocks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58728" y="1484784"/>
            <a:ext cx="2365200" cy="21816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矩形 4"/>
          <p:cNvSpPr/>
          <p:nvPr/>
        </p:nvSpPr>
        <p:spPr>
          <a:xfrm>
            <a:off x="750882" y="2267803"/>
            <a:ext cx="863089" cy="61555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β-actin</a:t>
            </a:r>
          </a:p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43KDa)</a:t>
            </a:r>
            <a:endParaRPr lang="zh-CN" altLang="en-US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zh-CN" alt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051" name="Picture 3"/>
          <p:cNvPicPr preferRelativeResize="0">
            <a:picLocks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51512" y="1484783"/>
            <a:ext cx="2365200" cy="2181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7" name="矩形 6"/>
          <p:cNvSpPr/>
          <p:nvPr/>
        </p:nvSpPr>
        <p:spPr>
          <a:xfrm>
            <a:off x="179512" y="12069"/>
            <a:ext cx="4572000" cy="646331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estern blotting Gels: </a:t>
            </a:r>
            <a:endParaRPr lang="en-US" altLang="zh-CN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3 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矩形 7"/>
          <p:cNvSpPr/>
          <p:nvPr/>
        </p:nvSpPr>
        <p:spPr>
          <a:xfrm>
            <a:off x="7164288" y="2267805"/>
            <a:ext cx="1006207" cy="61555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β-actin</a:t>
            </a:r>
          </a:p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43KDa)</a:t>
            </a:r>
            <a:endParaRPr lang="zh-CN" altLang="en-US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zh-CN" alt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矩形 8"/>
          <p:cNvSpPr/>
          <p:nvPr/>
        </p:nvSpPr>
        <p:spPr>
          <a:xfrm>
            <a:off x="1362123" y="4437112"/>
            <a:ext cx="6018189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3</a:t>
            </a:r>
            <a:r>
              <a:rPr lang="zh-CN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：</a:t>
            </a:r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ternal reference of each group of proteins</a:t>
            </a:r>
            <a:endParaRPr lang="zh-CN" altLang="zh-CN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8232561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8</TotalTime>
  <Words>229</Words>
  <Application>Microsoft Office PowerPoint</Application>
  <PresentationFormat>全屏显示(4:3)</PresentationFormat>
  <Paragraphs>54</Paragraphs>
  <Slides>6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6</vt:i4>
      </vt:variant>
    </vt:vector>
  </HeadingPairs>
  <TitlesOfParts>
    <vt:vector size="7" baseType="lpstr"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>HP Inc.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hp</dc:creator>
  <cp:lastModifiedBy>hp</cp:lastModifiedBy>
  <cp:revision>9</cp:revision>
  <dcterms:created xsi:type="dcterms:W3CDTF">2024-04-06T23:18:58Z</dcterms:created>
  <dcterms:modified xsi:type="dcterms:W3CDTF">2024-04-06T23:57:28Z</dcterms:modified>
</cp:coreProperties>
</file>